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85" r:id="rId3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ED95E99-B7A1-1BE7-64EA-78923252CF79}" name="Benito Santano, Patricia" initials="BSP" userId="S::p.benito@caldic.es::7f31c3c3-2429-4e70-a049-81e68bbd763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000"/>
    <a:srgbClr val="A5A5A5"/>
    <a:srgbClr val="ED7D31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3" d="100"/>
          <a:sy n="43" d="100"/>
        </p:scale>
        <p:origin x="256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834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46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95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595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82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82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590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792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911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081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604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563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519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FC616B-3C4A-4C31-AB2D-401B6128FEB5}" type="datetimeFigureOut">
              <a:rPr lang="en-US" smtClean="0"/>
              <a:t>9/2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271FC8-F8C0-4E02-B0D2-13AF2F4BB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72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FEE3757-4FDD-EAB7-5E45-D8EFACCEBBE3}"/>
              </a:ext>
            </a:extLst>
          </p:cNvPr>
          <p:cNvSpPr txBox="1"/>
          <p:nvPr/>
        </p:nvSpPr>
        <p:spPr>
          <a:xfrm>
            <a:off x="1182254" y="6756009"/>
            <a:ext cx="747221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S1</a:t>
            </a:r>
            <a:r>
              <a:rPr lang="en-US" dirty="0"/>
              <a:t>. </a:t>
            </a:r>
            <a:r>
              <a:rPr lang="en-US" sz="1800" dirty="0">
                <a:solidFill>
                  <a:srgbClr val="3A3838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arefaction curve obtained at the ASV level of the samples, once the </a:t>
            </a:r>
            <a:r>
              <a:rPr lang="en-US" sz="1800" dirty="0" err="1">
                <a:solidFill>
                  <a:srgbClr val="3A3838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hloroplastic</a:t>
            </a:r>
            <a:r>
              <a:rPr lang="en-US" sz="1800" dirty="0">
                <a:solidFill>
                  <a:srgbClr val="3A3838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nd mitochondrial readings have been filtered. </a:t>
            </a:r>
            <a:endParaRPr lang="es-ES" dirty="0"/>
          </a:p>
        </p:txBody>
      </p:sp>
      <p:pic>
        <p:nvPicPr>
          <p:cNvPr id="6" name="Image 9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734FD486-B7AE-2F4B-AA71-6B565788721D}"/>
              </a:ext>
            </a:extLst>
          </p:cNvPr>
          <p:cNvPicPr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86081" y="1242719"/>
            <a:ext cx="8229038" cy="5158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7072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C5A24D0-31DA-8EBB-B770-A66383CA006A}"/>
              </a:ext>
            </a:extLst>
          </p:cNvPr>
          <p:cNvSpPr txBox="1"/>
          <p:nvPr/>
        </p:nvSpPr>
        <p:spPr>
          <a:xfrm>
            <a:off x="1177636" y="7888618"/>
            <a:ext cx="7245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S2</a:t>
            </a:r>
            <a:r>
              <a:rPr lang="en-US" dirty="0"/>
              <a:t>. </a:t>
            </a:r>
            <a:r>
              <a:rPr lang="en-US" sz="1800" dirty="0">
                <a:solidFill>
                  <a:srgbClr val="3A3838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arefaction curve obtained at the ASV level of the samples, after filtering the readings from tomato and lettuce. </a:t>
            </a:r>
            <a:endParaRPr lang="es-ES" dirty="0">
              <a:highlight>
                <a:srgbClr val="FFFF00"/>
              </a:highlight>
            </a:endParaRPr>
          </a:p>
        </p:txBody>
      </p:sp>
      <p:pic>
        <p:nvPicPr>
          <p:cNvPr id="21" name="Image 26" descr="Gráfico&#10;&#10;Descripción generada automáticamente">
            <a:extLst>
              <a:ext uri="{FF2B5EF4-FFF2-40B4-BE49-F238E27FC236}">
                <a16:creationId xmlns:a16="http://schemas.microsoft.com/office/drawing/2014/main" id="{79C8A7DC-B07B-CA8B-FC7A-8965A5F5D0CA}"/>
              </a:ext>
            </a:extLst>
          </p:cNvPr>
          <p:cNvPicPr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09368" y="1133401"/>
            <a:ext cx="7894305" cy="6427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8844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3</TotalTime>
  <Words>49</Words>
  <Application>Microsoft Office PowerPoint</Application>
  <PresentationFormat>A3 Paper (297x420 mm)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ia Benito</dc:creator>
  <cp:lastModifiedBy>MDPI</cp:lastModifiedBy>
  <cp:revision>6</cp:revision>
  <dcterms:created xsi:type="dcterms:W3CDTF">2024-05-20T10:54:26Z</dcterms:created>
  <dcterms:modified xsi:type="dcterms:W3CDTF">2025-09-29T08:49:57Z</dcterms:modified>
</cp:coreProperties>
</file>